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</p:sldIdLst>
  <p:sldSz cx="13355638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C384EE9-6C63-430F-8AF6-90E46356B1E7}" v="6" dt="2023-12-27T01:28:16.01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4" d="100"/>
          <a:sy n="94" d="100"/>
        </p:scale>
        <p:origin x="288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yuwoong Kim" userId="c6581f603476f281" providerId="LiveId" clId="{6C384EE9-6C63-430F-8AF6-90E46356B1E7}"/>
    <pc:docChg chg="undo custSel modSld">
      <pc:chgData name="Kyuwoong Kim" userId="c6581f603476f281" providerId="LiveId" clId="{6C384EE9-6C63-430F-8AF6-90E46356B1E7}" dt="2023-12-27T04:49:25.142" v="108" actId="20577"/>
      <pc:docMkLst>
        <pc:docMk/>
      </pc:docMkLst>
      <pc:sldChg chg="addSp delSp modSp mod">
        <pc:chgData name="Kyuwoong Kim" userId="c6581f603476f281" providerId="LiveId" clId="{6C384EE9-6C63-430F-8AF6-90E46356B1E7}" dt="2023-12-27T04:49:25.142" v="108" actId="20577"/>
        <pc:sldMkLst>
          <pc:docMk/>
          <pc:sldMk cId="1037682986" sldId="257"/>
        </pc:sldMkLst>
        <pc:spChg chg="add mod">
          <ac:chgData name="Kyuwoong Kim" userId="c6581f603476f281" providerId="LiveId" clId="{6C384EE9-6C63-430F-8AF6-90E46356B1E7}" dt="2023-12-27T04:49:25.142" v="108" actId="20577"/>
          <ac:spMkLst>
            <pc:docMk/>
            <pc:sldMk cId="1037682986" sldId="257"/>
            <ac:spMk id="12" creationId="{D9CF38EF-56BB-5B5F-9603-974CFEE48FEC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15" creationId="{0110422B-A330-DB43-E93C-5DF9FB920B6B}"/>
          </ac:spMkLst>
        </pc:spChg>
        <pc:spChg chg="mod or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21" creationId="{12112411-3BB9-15BD-96F2-4DFAD9EE62C8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33" creationId="{F7621210-4DEB-DC03-123C-1F7219027A33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34" creationId="{0F4EDBFB-743C-9551-9B31-900B8968843C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35" creationId="{70AB1660-B3CE-77D2-5D8C-D8408DC702D9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36" creationId="{41517E53-6946-C0A4-3CEB-705AB7147267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37" creationId="{536D7B9A-9813-1BD4-26D6-5FCAFEC49DC0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38" creationId="{75830CAC-6B12-E0E8-422D-B6C9400A1632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39" creationId="{59842221-111E-3077-4793-03A331493134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40" creationId="{E1EB41B9-F25F-6955-8F1D-4E3E210433FC}"/>
          </ac:spMkLst>
        </pc:spChg>
        <pc:spChg chg="mod or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41" creationId="{681649CF-8F1A-BE31-7BC6-0C48E9FF9B97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43" creationId="{EB886F77-C41C-CC57-767F-E8CFA9FF7E04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44" creationId="{1B923759-EE7D-5F6F-083F-A2A6D42FF4E3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45" creationId="{8E099F1B-C4B0-CB68-3D46-F97CB0D9FA0B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46" creationId="{266B1B07-D5D4-8078-C2BF-925F81997393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47" creationId="{4CFE6C89-8253-9163-0D05-478393A537F7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48" creationId="{622735BE-5519-093A-F7CB-E3D635556409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49" creationId="{B0515DB5-2198-0BD1-261B-331C1CC43A0F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50" creationId="{28E6E8D2-F0CF-7635-08AB-13818695D9FD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51" creationId="{58E86152-40C0-3EC5-B47C-887EC496857E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52" creationId="{A76C66C2-A7C7-B858-D717-0AAC2D46539E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53" creationId="{2A47FEAD-69CC-726F-A02C-A9A4AC48BC06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54" creationId="{6717F8D1-BF07-A098-4DC1-4AAD52E17891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55" creationId="{EF4E0080-96C2-16C3-95B9-1A58C94F5A70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56" creationId="{A8E53E1A-EAD9-987A-69DE-A3539E8F3A24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57" creationId="{D8599CB8-A876-D470-D910-AF42CADEE583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58" creationId="{DD4F08F9-5B11-7390-36F3-DB8D8A134D9B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59" creationId="{3EDD9793-3B26-CE2E-C2F8-BFE20E640AE8}"/>
          </ac:spMkLst>
        </pc:spChg>
        <pc:picChg chg="add mod ord">
          <ac:chgData name="Kyuwoong Kim" userId="c6581f603476f281" providerId="LiveId" clId="{6C384EE9-6C63-430F-8AF6-90E46356B1E7}" dt="2023-12-27T01:26:20.300" v="94" actId="1076"/>
          <ac:picMkLst>
            <pc:docMk/>
            <pc:sldMk cId="1037682986" sldId="257"/>
            <ac:picMk id="2" creationId="{89F1FC39-C451-D940-77C3-EB949E3015FC}"/>
          </ac:picMkLst>
        </pc:picChg>
        <pc:picChg chg="del">
          <ac:chgData name="Kyuwoong Kim" userId="c6581f603476f281" providerId="LiveId" clId="{6C384EE9-6C63-430F-8AF6-90E46356B1E7}" dt="2023-12-27T01:21:36.465" v="2" actId="478"/>
          <ac:picMkLst>
            <pc:docMk/>
            <pc:sldMk cId="1037682986" sldId="257"/>
            <ac:picMk id="3" creationId="{3DA2BF18-C613-9863-29D7-87EE3DC84849}"/>
          </ac:picMkLst>
        </pc:picChg>
        <pc:picChg chg="add mod ord">
          <ac:chgData name="Kyuwoong Kim" userId="c6581f603476f281" providerId="LiveId" clId="{6C384EE9-6C63-430F-8AF6-90E46356B1E7}" dt="2023-12-27T01:26:20.300" v="94" actId="1076"/>
          <ac:picMkLst>
            <pc:docMk/>
            <pc:sldMk cId="1037682986" sldId="257"/>
            <ac:picMk id="4" creationId="{78CFC0BB-A8AA-3A99-B3A4-0F096EF75EF2}"/>
          </ac:picMkLst>
        </pc:picChg>
        <pc:picChg chg="add mod ord">
          <ac:chgData name="Kyuwoong Kim" userId="c6581f603476f281" providerId="LiveId" clId="{6C384EE9-6C63-430F-8AF6-90E46356B1E7}" dt="2023-12-27T01:26:20.300" v="94" actId="1076"/>
          <ac:picMkLst>
            <pc:docMk/>
            <pc:sldMk cId="1037682986" sldId="257"/>
            <ac:picMk id="5" creationId="{B7846E34-7695-90B4-ED71-8D35E87029BD}"/>
          </ac:picMkLst>
        </pc:picChg>
        <pc:picChg chg="add mod ord">
          <ac:chgData name="Kyuwoong Kim" userId="c6581f603476f281" providerId="LiveId" clId="{6C384EE9-6C63-430F-8AF6-90E46356B1E7}" dt="2023-12-27T01:26:20.300" v="94" actId="1076"/>
          <ac:picMkLst>
            <pc:docMk/>
            <pc:sldMk cId="1037682986" sldId="257"/>
            <ac:picMk id="6" creationId="{05B99E67-0C4F-310E-2828-FDAFE392684F}"/>
          </ac:picMkLst>
        </pc:picChg>
        <pc:picChg chg="del">
          <ac:chgData name="Kyuwoong Kim" userId="c6581f603476f281" providerId="LiveId" clId="{6C384EE9-6C63-430F-8AF6-90E46356B1E7}" dt="2023-12-27T01:21:35.980" v="1" actId="478"/>
          <ac:picMkLst>
            <pc:docMk/>
            <pc:sldMk cId="1037682986" sldId="257"/>
            <ac:picMk id="7" creationId="{7C63AA1C-3B9F-F182-95A6-FFB796DF3BDF}"/>
          </ac:picMkLst>
        </pc:picChg>
        <pc:picChg chg="del">
          <ac:chgData name="Kyuwoong Kim" userId="c6581f603476f281" providerId="LiveId" clId="{6C384EE9-6C63-430F-8AF6-90E46356B1E7}" dt="2023-12-27T01:21:35.406" v="0" actId="478"/>
          <ac:picMkLst>
            <pc:docMk/>
            <pc:sldMk cId="1037682986" sldId="257"/>
            <ac:picMk id="8" creationId="{9ADBDB19-291D-762F-285E-37BC4E4DD745}"/>
          </ac:picMkLst>
        </pc:picChg>
        <pc:picChg chg="del">
          <ac:chgData name="Kyuwoong Kim" userId="c6581f603476f281" providerId="LiveId" clId="{6C384EE9-6C63-430F-8AF6-90E46356B1E7}" dt="2023-12-27T01:21:37.949" v="5" actId="478"/>
          <ac:picMkLst>
            <pc:docMk/>
            <pc:sldMk cId="1037682986" sldId="257"/>
            <ac:picMk id="9" creationId="{07E698BB-6FF8-6B7E-9D41-A0B8AC24415D}"/>
          </ac:picMkLst>
        </pc:picChg>
        <pc:picChg chg="add mod ord">
          <ac:chgData name="Kyuwoong Kim" userId="c6581f603476f281" providerId="LiveId" clId="{6C384EE9-6C63-430F-8AF6-90E46356B1E7}" dt="2023-12-27T01:26:20.300" v="94" actId="1076"/>
          <ac:picMkLst>
            <pc:docMk/>
            <pc:sldMk cId="1037682986" sldId="257"/>
            <ac:picMk id="10" creationId="{184CEB08-BB23-794B-AD8A-86F485ED0A75}"/>
          </ac:picMkLst>
        </pc:picChg>
        <pc:picChg chg="add mod ord">
          <ac:chgData name="Kyuwoong Kim" userId="c6581f603476f281" providerId="LiveId" clId="{6C384EE9-6C63-430F-8AF6-90E46356B1E7}" dt="2023-12-27T01:26:20.300" v="94" actId="1076"/>
          <ac:picMkLst>
            <pc:docMk/>
            <pc:sldMk cId="1037682986" sldId="257"/>
            <ac:picMk id="11" creationId="{0D3255E8-C6D7-5AB4-41DB-A9E9AED6C338}"/>
          </ac:picMkLst>
        </pc:picChg>
        <pc:picChg chg="del">
          <ac:chgData name="Kyuwoong Kim" userId="c6581f603476f281" providerId="LiveId" clId="{6C384EE9-6C63-430F-8AF6-90E46356B1E7}" dt="2023-12-27T01:21:37.442" v="4" actId="478"/>
          <ac:picMkLst>
            <pc:docMk/>
            <pc:sldMk cId="1037682986" sldId="257"/>
            <ac:picMk id="13" creationId="{B53CCBB4-0B80-D41A-BC82-1969AE576977}"/>
          </ac:picMkLst>
        </pc:picChg>
        <pc:picChg chg="del">
          <ac:chgData name="Kyuwoong Kim" userId="c6581f603476f281" providerId="LiveId" clId="{6C384EE9-6C63-430F-8AF6-90E46356B1E7}" dt="2023-12-27T01:21:37.016" v="3" actId="478"/>
          <ac:picMkLst>
            <pc:docMk/>
            <pc:sldMk cId="1037682986" sldId="257"/>
            <ac:picMk id="14" creationId="{9B354F50-063D-9DB5-9BDE-88FD7F5DC280}"/>
          </ac:picMkLst>
        </pc:picChg>
      </pc:sldChg>
    </pc:docChg>
  </pc:docChgLst>
  <pc:docChgLst>
    <pc:chgData name="Kyuwoong Kim" userId="c6581f603476f281" providerId="LiveId" clId="{AB3AD8FA-EAF4-40B3-BC33-1A83D204ECFD}"/>
    <pc:docChg chg="undo custSel modSld">
      <pc:chgData name="Kyuwoong Kim" userId="c6581f603476f281" providerId="LiveId" clId="{AB3AD8FA-EAF4-40B3-BC33-1A83D204ECFD}" dt="2023-12-22T02:31:49.804" v="328" actId="20577"/>
      <pc:docMkLst>
        <pc:docMk/>
      </pc:docMkLst>
      <pc:sldChg chg="addSp delSp modSp mod">
        <pc:chgData name="Kyuwoong Kim" userId="c6581f603476f281" providerId="LiveId" clId="{AB3AD8FA-EAF4-40B3-BC33-1A83D204ECFD}" dt="2023-12-22T02:31:49.804" v="328" actId="20577"/>
        <pc:sldMkLst>
          <pc:docMk/>
          <pc:sldMk cId="1037682986" sldId="257"/>
        </pc:sldMkLst>
        <pc:spChg chg="del">
          <ac:chgData name="Kyuwoong Kim" userId="c6581f603476f281" providerId="LiveId" clId="{AB3AD8FA-EAF4-40B3-BC33-1A83D204ECFD}" dt="2023-12-22T01:43:43.821" v="0" actId="478"/>
          <ac:spMkLst>
            <pc:docMk/>
            <pc:sldMk cId="1037682986" sldId="257"/>
            <ac:spMk id="2" creationId="{5F4CB461-2D7B-9907-267D-13399AEB1AD4}"/>
          </ac:spMkLst>
        </pc:spChg>
        <pc:spChg chg="add mod">
          <ac:chgData name="Kyuwoong Kim" userId="c6581f603476f281" providerId="LiveId" clId="{AB3AD8FA-EAF4-40B3-BC33-1A83D204ECFD}" dt="2023-12-22T02:31:49.804" v="328" actId="20577"/>
          <ac:spMkLst>
            <pc:docMk/>
            <pc:sldMk cId="1037682986" sldId="257"/>
            <ac:spMk id="15" creationId="{0110422B-A330-DB43-E93C-5DF9FB920B6B}"/>
          </ac:spMkLst>
        </pc:spChg>
        <pc:spChg chg="add del mod">
          <ac:chgData name="Kyuwoong Kim" userId="c6581f603476f281" providerId="LiveId" clId="{AB3AD8FA-EAF4-40B3-BC33-1A83D204ECFD}" dt="2023-12-22T01:51:12.077" v="157" actId="478"/>
          <ac:spMkLst>
            <pc:docMk/>
            <pc:sldMk cId="1037682986" sldId="257"/>
            <ac:spMk id="16" creationId="{8AB8FFF6-C704-2E86-DF92-794B3C588EA3}"/>
          </ac:spMkLst>
        </pc:spChg>
        <pc:spChg chg="add del mod">
          <ac:chgData name="Kyuwoong Kim" userId="c6581f603476f281" providerId="LiveId" clId="{AB3AD8FA-EAF4-40B3-BC33-1A83D204ECFD}" dt="2023-12-22T01:51:14.189" v="158" actId="478"/>
          <ac:spMkLst>
            <pc:docMk/>
            <pc:sldMk cId="1037682986" sldId="257"/>
            <ac:spMk id="17" creationId="{6DA3FB4B-36A2-59BE-3D23-1D7D35BB8FD2}"/>
          </ac:spMkLst>
        </pc:spChg>
        <pc:spChg chg="add del mod">
          <ac:chgData name="Kyuwoong Kim" userId="c6581f603476f281" providerId="LiveId" clId="{AB3AD8FA-EAF4-40B3-BC33-1A83D204ECFD}" dt="2023-12-22T01:51:16.108" v="159" actId="478"/>
          <ac:spMkLst>
            <pc:docMk/>
            <pc:sldMk cId="1037682986" sldId="257"/>
            <ac:spMk id="18" creationId="{3F5E720C-6459-2406-81C8-4FA1EE564878}"/>
          </ac:spMkLst>
        </pc:spChg>
        <pc:spChg chg="add del mod">
          <ac:chgData name="Kyuwoong Kim" userId="c6581f603476f281" providerId="LiveId" clId="{AB3AD8FA-EAF4-40B3-BC33-1A83D204ECFD}" dt="2023-12-22T01:51:17.217" v="160" actId="478"/>
          <ac:spMkLst>
            <pc:docMk/>
            <pc:sldMk cId="1037682986" sldId="257"/>
            <ac:spMk id="19" creationId="{72849703-0F90-A9B9-ED24-D814A8097F51}"/>
          </ac:spMkLst>
        </pc:spChg>
        <pc:spChg chg="add del mod">
          <ac:chgData name="Kyuwoong Kim" userId="c6581f603476f281" providerId="LiveId" clId="{AB3AD8FA-EAF4-40B3-BC33-1A83D204ECFD}" dt="2023-12-22T01:51:18.431" v="161" actId="478"/>
          <ac:spMkLst>
            <pc:docMk/>
            <pc:sldMk cId="1037682986" sldId="257"/>
            <ac:spMk id="20" creationId="{8CEB927C-7706-70D6-FDC5-BCA69BD655AD}"/>
          </ac:spMkLst>
        </pc:spChg>
        <pc:spChg chg="add mod">
          <ac:chgData name="Kyuwoong Kim" userId="c6581f603476f281" providerId="LiveId" clId="{AB3AD8FA-EAF4-40B3-BC33-1A83D204ECFD}" dt="2023-12-22T02:08:51.164" v="288" actId="1076"/>
          <ac:spMkLst>
            <pc:docMk/>
            <pc:sldMk cId="1037682986" sldId="257"/>
            <ac:spMk id="21" creationId="{12112411-3BB9-15BD-96F2-4DFAD9EE62C8}"/>
          </ac:spMkLst>
        </pc:spChg>
        <pc:spChg chg="del">
          <ac:chgData name="Kyuwoong Kim" userId="c6581f603476f281" providerId="LiveId" clId="{AB3AD8FA-EAF4-40B3-BC33-1A83D204ECFD}" dt="2023-12-22T01:43:43.821" v="0" actId="478"/>
          <ac:spMkLst>
            <pc:docMk/>
            <pc:sldMk cId="1037682986" sldId="257"/>
            <ac:spMk id="22" creationId="{21BF83AB-55A3-F8DC-0AC5-9BAB80BDCDE9}"/>
          </ac:spMkLst>
        </pc:spChg>
        <pc:spChg chg="del">
          <ac:chgData name="Kyuwoong Kim" userId="c6581f603476f281" providerId="LiveId" clId="{AB3AD8FA-EAF4-40B3-BC33-1A83D204ECFD}" dt="2023-12-22T01:43:46.770" v="1" actId="478"/>
          <ac:spMkLst>
            <pc:docMk/>
            <pc:sldMk cId="1037682986" sldId="257"/>
            <ac:spMk id="23" creationId="{1489FC61-41C2-11CB-9C3F-8D4E13252A84}"/>
          </ac:spMkLst>
        </pc:spChg>
        <pc:spChg chg="del">
          <ac:chgData name="Kyuwoong Kim" userId="c6581f603476f281" providerId="LiveId" clId="{AB3AD8FA-EAF4-40B3-BC33-1A83D204ECFD}" dt="2023-12-22T01:43:43.821" v="0" actId="478"/>
          <ac:spMkLst>
            <pc:docMk/>
            <pc:sldMk cId="1037682986" sldId="257"/>
            <ac:spMk id="24" creationId="{9B18D7A9-F4A3-439B-BAC6-01EA93319108}"/>
          </ac:spMkLst>
        </pc:spChg>
        <pc:spChg chg="del">
          <ac:chgData name="Kyuwoong Kim" userId="c6581f603476f281" providerId="LiveId" clId="{AB3AD8FA-EAF4-40B3-BC33-1A83D204ECFD}" dt="2023-12-22T01:43:43.821" v="0" actId="478"/>
          <ac:spMkLst>
            <pc:docMk/>
            <pc:sldMk cId="1037682986" sldId="257"/>
            <ac:spMk id="25" creationId="{0CDCDC3F-BCC9-07D3-BFF9-B851EC094AF4}"/>
          </ac:spMkLst>
        </pc:spChg>
        <pc:spChg chg="del">
          <ac:chgData name="Kyuwoong Kim" userId="c6581f603476f281" providerId="LiveId" clId="{AB3AD8FA-EAF4-40B3-BC33-1A83D204ECFD}" dt="2023-12-22T01:43:46.770" v="1" actId="478"/>
          <ac:spMkLst>
            <pc:docMk/>
            <pc:sldMk cId="1037682986" sldId="257"/>
            <ac:spMk id="26" creationId="{BCDA9B84-EFA7-F085-870A-66C700B40AE6}"/>
          </ac:spMkLst>
        </pc:spChg>
        <pc:spChg chg="del">
          <ac:chgData name="Kyuwoong Kim" userId="c6581f603476f281" providerId="LiveId" clId="{AB3AD8FA-EAF4-40B3-BC33-1A83D204ECFD}" dt="2023-12-22T01:43:43.821" v="0" actId="478"/>
          <ac:spMkLst>
            <pc:docMk/>
            <pc:sldMk cId="1037682986" sldId="257"/>
            <ac:spMk id="27" creationId="{E847B7FE-C20F-8DDD-35A2-E1F6530A4C2D}"/>
          </ac:spMkLst>
        </pc:spChg>
        <pc:spChg chg="del">
          <ac:chgData name="Kyuwoong Kim" userId="c6581f603476f281" providerId="LiveId" clId="{AB3AD8FA-EAF4-40B3-BC33-1A83D204ECFD}" dt="2023-12-22T01:43:43.821" v="0" actId="478"/>
          <ac:spMkLst>
            <pc:docMk/>
            <pc:sldMk cId="1037682986" sldId="257"/>
            <ac:spMk id="28" creationId="{49D37221-D60E-1483-6A81-C4EDFF92F184}"/>
          </ac:spMkLst>
        </pc:spChg>
        <pc:spChg chg="del">
          <ac:chgData name="Kyuwoong Kim" userId="c6581f603476f281" providerId="LiveId" clId="{AB3AD8FA-EAF4-40B3-BC33-1A83D204ECFD}" dt="2023-12-22T01:43:43.821" v="0" actId="478"/>
          <ac:spMkLst>
            <pc:docMk/>
            <pc:sldMk cId="1037682986" sldId="257"/>
            <ac:spMk id="29" creationId="{966520C8-1DD6-B778-F62E-B052E26DA917}"/>
          </ac:spMkLst>
        </pc:spChg>
        <pc:spChg chg="del">
          <ac:chgData name="Kyuwoong Kim" userId="c6581f603476f281" providerId="LiveId" clId="{AB3AD8FA-EAF4-40B3-BC33-1A83D204ECFD}" dt="2023-12-22T01:43:43.821" v="0" actId="478"/>
          <ac:spMkLst>
            <pc:docMk/>
            <pc:sldMk cId="1037682986" sldId="257"/>
            <ac:spMk id="30" creationId="{1BA8DCDA-7410-3AA5-557C-54A052C1965A}"/>
          </ac:spMkLst>
        </pc:spChg>
        <pc:spChg chg="del">
          <ac:chgData name="Kyuwoong Kim" userId="c6581f603476f281" providerId="LiveId" clId="{AB3AD8FA-EAF4-40B3-BC33-1A83D204ECFD}" dt="2023-12-22T01:43:43.821" v="0" actId="478"/>
          <ac:spMkLst>
            <pc:docMk/>
            <pc:sldMk cId="1037682986" sldId="257"/>
            <ac:spMk id="31" creationId="{7EC138EB-071C-CE0C-9776-C14A25101744}"/>
          </ac:spMkLst>
        </pc:spChg>
        <pc:spChg chg="del">
          <ac:chgData name="Kyuwoong Kim" userId="c6581f603476f281" providerId="LiveId" clId="{AB3AD8FA-EAF4-40B3-BC33-1A83D204ECFD}" dt="2023-12-22T01:43:43.821" v="0" actId="478"/>
          <ac:spMkLst>
            <pc:docMk/>
            <pc:sldMk cId="1037682986" sldId="257"/>
            <ac:spMk id="32" creationId="{576E202D-A068-46B9-195A-063327A51F07}"/>
          </ac:spMkLst>
        </pc:spChg>
        <pc:spChg chg="add mod">
          <ac:chgData name="Kyuwoong Kim" userId="c6581f603476f281" providerId="LiveId" clId="{AB3AD8FA-EAF4-40B3-BC33-1A83D204ECFD}" dt="2023-12-22T02:08:51.164" v="288" actId="1076"/>
          <ac:spMkLst>
            <pc:docMk/>
            <pc:sldMk cId="1037682986" sldId="257"/>
            <ac:spMk id="33" creationId="{F7621210-4DEB-DC03-123C-1F7219027A33}"/>
          </ac:spMkLst>
        </pc:spChg>
        <pc:spChg chg="add mod">
          <ac:chgData name="Kyuwoong Kim" userId="c6581f603476f281" providerId="LiveId" clId="{AB3AD8FA-EAF4-40B3-BC33-1A83D204ECFD}" dt="2023-12-22T02:08:51.164" v="288" actId="1076"/>
          <ac:spMkLst>
            <pc:docMk/>
            <pc:sldMk cId="1037682986" sldId="257"/>
            <ac:spMk id="34" creationId="{0F4EDBFB-743C-9551-9B31-900B8968843C}"/>
          </ac:spMkLst>
        </pc:spChg>
        <pc:spChg chg="add mod">
          <ac:chgData name="Kyuwoong Kim" userId="c6581f603476f281" providerId="LiveId" clId="{AB3AD8FA-EAF4-40B3-BC33-1A83D204ECFD}" dt="2023-12-22T02:08:22.129" v="281" actId="1076"/>
          <ac:spMkLst>
            <pc:docMk/>
            <pc:sldMk cId="1037682986" sldId="257"/>
            <ac:spMk id="35" creationId="{70AB1660-B3CE-77D2-5D8C-D8408DC702D9}"/>
          </ac:spMkLst>
        </pc:spChg>
        <pc:spChg chg="add mod">
          <ac:chgData name="Kyuwoong Kim" userId="c6581f603476f281" providerId="LiveId" clId="{AB3AD8FA-EAF4-40B3-BC33-1A83D204ECFD}" dt="2023-12-22T02:08:22.129" v="281" actId="1076"/>
          <ac:spMkLst>
            <pc:docMk/>
            <pc:sldMk cId="1037682986" sldId="257"/>
            <ac:spMk id="36" creationId="{41517E53-6946-C0A4-3CEB-705AB7147267}"/>
          </ac:spMkLst>
        </pc:spChg>
        <pc:spChg chg="add mod">
          <ac:chgData name="Kyuwoong Kim" userId="c6581f603476f281" providerId="LiveId" clId="{AB3AD8FA-EAF4-40B3-BC33-1A83D204ECFD}" dt="2023-12-22T02:08:22.129" v="281" actId="1076"/>
          <ac:spMkLst>
            <pc:docMk/>
            <pc:sldMk cId="1037682986" sldId="257"/>
            <ac:spMk id="37" creationId="{536D7B9A-9813-1BD4-26D6-5FCAFEC49DC0}"/>
          </ac:spMkLst>
        </pc:spChg>
        <pc:spChg chg="add mod">
          <ac:chgData name="Kyuwoong Kim" userId="c6581f603476f281" providerId="LiveId" clId="{AB3AD8FA-EAF4-40B3-BC33-1A83D204ECFD}" dt="2023-12-22T02:08:51.164" v="288" actId="1076"/>
          <ac:spMkLst>
            <pc:docMk/>
            <pc:sldMk cId="1037682986" sldId="257"/>
            <ac:spMk id="38" creationId="{75830CAC-6B12-E0E8-422D-B6C9400A1632}"/>
          </ac:spMkLst>
        </pc:spChg>
        <pc:spChg chg="add mod">
          <ac:chgData name="Kyuwoong Kim" userId="c6581f603476f281" providerId="LiveId" clId="{AB3AD8FA-EAF4-40B3-BC33-1A83D204ECFD}" dt="2023-12-22T02:08:22.129" v="281" actId="1076"/>
          <ac:spMkLst>
            <pc:docMk/>
            <pc:sldMk cId="1037682986" sldId="257"/>
            <ac:spMk id="39" creationId="{59842221-111E-3077-4793-03A331493134}"/>
          </ac:spMkLst>
        </pc:spChg>
        <pc:spChg chg="add mod">
          <ac:chgData name="Kyuwoong Kim" userId="c6581f603476f281" providerId="LiveId" clId="{AB3AD8FA-EAF4-40B3-BC33-1A83D204ECFD}" dt="2023-12-22T02:08:51.164" v="288" actId="1076"/>
          <ac:spMkLst>
            <pc:docMk/>
            <pc:sldMk cId="1037682986" sldId="257"/>
            <ac:spMk id="40" creationId="{E1EB41B9-F25F-6955-8F1D-4E3E210433FC}"/>
          </ac:spMkLst>
        </pc:spChg>
        <pc:spChg chg="add mod">
          <ac:chgData name="Kyuwoong Kim" userId="c6581f603476f281" providerId="LiveId" clId="{AB3AD8FA-EAF4-40B3-BC33-1A83D204ECFD}" dt="2023-12-22T02:08:22.129" v="281" actId="1076"/>
          <ac:spMkLst>
            <pc:docMk/>
            <pc:sldMk cId="1037682986" sldId="257"/>
            <ac:spMk id="41" creationId="{681649CF-8F1A-BE31-7BC6-0C48E9FF9B97}"/>
          </ac:spMkLst>
        </pc:spChg>
        <pc:spChg chg="add del mod">
          <ac:chgData name="Kyuwoong Kim" userId="c6581f603476f281" providerId="LiveId" clId="{AB3AD8FA-EAF4-40B3-BC33-1A83D204ECFD}" dt="2023-12-22T01:51:02.103" v="142" actId="478"/>
          <ac:spMkLst>
            <pc:docMk/>
            <pc:sldMk cId="1037682986" sldId="257"/>
            <ac:spMk id="42" creationId="{7933FCEF-10E0-36C5-EEB4-98B317E8E4E7}"/>
          </ac:spMkLst>
        </pc:spChg>
        <pc:spChg chg="add mod">
          <ac:chgData name="Kyuwoong Kim" userId="c6581f603476f281" providerId="LiveId" clId="{AB3AD8FA-EAF4-40B3-BC33-1A83D204ECFD}" dt="2023-12-22T02:09:50.979" v="295" actId="1076"/>
          <ac:spMkLst>
            <pc:docMk/>
            <pc:sldMk cId="1037682986" sldId="257"/>
            <ac:spMk id="43" creationId="{EB886F77-C41C-CC57-767F-E8CFA9FF7E04}"/>
          </ac:spMkLst>
        </pc:spChg>
        <pc:spChg chg="add mod">
          <ac:chgData name="Kyuwoong Kim" userId="c6581f603476f281" providerId="LiveId" clId="{AB3AD8FA-EAF4-40B3-BC33-1A83D204ECFD}" dt="2023-12-22T02:09:55.309" v="296" actId="1076"/>
          <ac:spMkLst>
            <pc:docMk/>
            <pc:sldMk cId="1037682986" sldId="257"/>
            <ac:spMk id="44" creationId="{1B923759-EE7D-5F6F-083F-A2A6D42FF4E3}"/>
          </ac:spMkLst>
        </pc:spChg>
        <pc:spChg chg="add mod">
          <ac:chgData name="Kyuwoong Kim" userId="c6581f603476f281" providerId="LiveId" clId="{AB3AD8FA-EAF4-40B3-BC33-1A83D204ECFD}" dt="2023-12-22T02:09:36.642" v="293" actId="1076"/>
          <ac:spMkLst>
            <pc:docMk/>
            <pc:sldMk cId="1037682986" sldId="257"/>
            <ac:spMk id="45" creationId="{8E099F1B-C4B0-CB68-3D46-F97CB0D9FA0B}"/>
          </ac:spMkLst>
        </pc:spChg>
        <pc:spChg chg="add mod">
          <ac:chgData name="Kyuwoong Kim" userId="c6581f603476f281" providerId="LiveId" clId="{AB3AD8FA-EAF4-40B3-BC33-1A83D204ECFD}" dt="2023-12-22T02:09:31.376" v="292" actId="1076"/>
          <ac:spMkLst>
            <pc:docMk/>
            <pc:sldMk cId="1037682986" sldId="257"/>
            <ac:spMk id="46" creationId="{266B1B07-D5D4-8078-C2BF-925F81997393}"/>
          </ac:spMkLst>
        </pc:spChg>
        <pc:spChg chg="add mod">
          <ac:chgData name="Kyuwoong Kim" userId="c6581f603476f281" providerId="LiveId" clId="{AB3AD8FA-EAF4-40B3-BC33-1A83D204ECFD}" dt="2023-12-22T02:09:27.982" v="291" actId="1076"/>
          <ac:spMkLst>
            <pc:docMk/>
            <pc:sldMk cId="1037682986" sldId="257"/>
            <ac:spMk id="47" creationId="{4CFE6C89-8253-9163-0D05-478393A537F7}"/>
          </ac:spMkLst>
        </pc:spChg>
        <pc:spChg chg="add mod">
          <ac:chgData name="Kyuwoong Kim" userId="c6581f603476f281" providerId="LiveId" clId="{AB3AD8FA-EAF4-40B3-BC33-1A83D204ECFD}" dt="2023-12-22T02:08:51.164" v="288" actId="1076"/>
          <ac:spMkLst>
            <pc:docMk/>
            <pc:sldMk cId="1037682986" sldId="257"/>
            <ac:spMk id="48" creationId="{622735BE-5519-093A-F7CB-E3D635556409}"/>
          </ac:spMkLst>
        </pc:spChg>
        <pc:spChg chg="add mod">
          <ac:chgData name="Kyuwoong Kim" userId="c6581f603476f281" providerId="LiveId" clId="{AB3AD8FA-EAF4-40B3-BC33-1A83D204ECFD}" dt="2023-12-22T02:08:51.164" v="288" actId="1076"/>
          <ac:spMkLst>
            <pc:docMk/>
            <pc:sldMk cId="1037682986" sldId="257"/>
            <ac:spMk id="49" creationId="{B0515DB5-2198-0BD1-261B-331C1CC43A0F}"/>
          </ac:spMkLst>
        </pc:spChg>
        <pc:spChg chg="add mod">
          <ac:chgData name="Kyuwoong Kim" userId="c6581f603476f281" providerId="LiveId" clId="{AB3AD8FA-EAF4-40B3-BC33-1A83D204ECFD}" dt="2023-12-22T02:08:51.164" v="288" actId="1076"/>
          <ac:spMkLst>
            <pc:docMk/>
            <pc:sldMk cId="1037682986" sldId="257"/>
            <ac:spMk id="50" creationId="{28E6E8D2-F0CF-7635-08AB-13818695D9FD}"/>
          </ac:spMkLst>
        </pc:spChg>
        <pc:spChg chg="add mod">
          <ac:chgData name="Kyuwoong Kim" userId="c6581f603476f281" providerId="LiveId" clId="{AB3AD8FA-EAF4-40B3-BC33-1A83D204ECFD}" dt="2023-12-22T02:08:51.164" v="288" actId="1076"/>
          <ac:spMkLst>
            <pc:docMk/>
            <pc:sldMk cId="1037682986" sldId="257"/>
            <ac:spMk id="51" creationId="{58E86152-40C0-3EC5-B47C-887EC496857E}"/>
          </ac:spMkLst>
        </pc:spChg>
        <pc:spChg chg="add mod">
          <ac:chgData name="Kyuwoong Kim" userId="c6581f603476f281" providerId="LiveId" clId="{AB3AD8FA-EAF4-40B3-BC33-1A83D204ECFD}" dt="2023-12-22T02:08:51.164" v="288" actId="1076"/>
          <ac:spMkLst>
            <pc:docMk/>
            <pc:sldMk cId="1037682986" sldId="257"/>
            <ac:spMk id="52" creationId="{A76C66C2-A7C7-B858-D717-0AAC2D46539E}"/>
          </ac:spMkLst>
        </pc:spChg>
        <pc:spChg chg="add mod">
          <ac:chgData name="Kyuwoong Kim" userId="c6581f603476f281" providerId="LiveId" clId="{AB3AD8FA-EAF4-40B3-BC33-1A83D204ECFD}" dt="2023-12-22T02:08:51.164" v="288" actId="1076"/>
          <ac:spMkLst>
            <pc:docMk/>
            <pc:sldMk cId="1037682986" sldId="257"/>
            <ac:spMk id="53" creationId="{2A47FEAD-69CC-726F-A02C-A9A4AC48BC06}"/>
          </ac:spMkLst>
        </pc:spChg>
        <pc:spChg chg="add mod">
          <ac:chgData name="Kyuwoong Kim" userId="c6581f603476f281" providerId="LiveId" clId="{AB3AD8FA-EAF4-40B3-BC33-1A83D204ECFD}" dt="2023-12-22T02:08:22.129" v="281" actId="1076"/>
          <ac:spMkLst>
            <pc:docMk/>
            <pc:sldMk cId="1037682986" sldId="257"/>
            <ac:spMk id="54" creationId="{6717F8D1-BF07-A098-4DC1-4AAD52E17891}"/>
          </ac:spMkLst>
        </pc:spChg>
        <pc:spChg chg="add mod">
          <ac:chgData name="Kyuwoong Kim" userId="c6581f603476f281" providerId="LiveId" clId="{AB3AD8FA-EAF4-40B3-BC33-1A83D204ECFD}" dt="2023-12-22T02:08:22.129" v="281" actId="1076"/>
          <ac:spMkLst>
            <pc:docMk/>
            <pc:sldMk cId="1037682986" sldId="257"/>
            <ac:spMk id="55" creationId="{EF4E0080-96C2-16C3-95B9-1A58C94F5A70}"/>
          </ac:spMkLst>
        </pc:spChg>
        <pc:spChg chg="add mod">
          <ac:chgData name="Kyuwoong Kim" userId="c6581f603476f281" providerId="LiveId" clId="{AB3AD8FA-EAF4-40B3-BC33-1A83D204ECFD}" dt="2023-12-22T02:08:22.129" v="281" actId="1076"/>
          <ac:spMkLst>
            <pc:docMk/>
            <pc:sldMk cId="1037682986" sldId="257"/>
            <ac:spMk id="56" creationId="{A8E53E1A-EAD9-987A-69DE-A3539E8F3A24}"/>
          </ac:spMkLst>
        </pc:spChg>
        <pc:spChg chg="add mod">
          <ac:chgData name="Kyuwoong Kim" userId="c6581f603476f281" providerId="LiveId" clId="{AB3AD8FA-EAF4-40B3-BC33-1A83D204ECFD}" dt="2023-12-22T02:08:22.129" v="281" actId="1076"/>
          <ac:spMkLst>
            <pc:docMk/>
            <pc:sldMk cId="1037682986" sldId="257"/>
            <ac:spMk id="57" creationId="{D8599CB8-A876-D470-D910-AF42CADEE583}"/>
          </ac:spMkLst>
        </pc:spChg>
        <pc:spChg chg="add mod">
          <ac:chgData name="Kyuwoong Kim" userId="c6581f603476f281" providerId="LiveId" clId="{AB3AD8FA-EAF4-40B3-BC33-1A83D204ECFD}" dt="2023-12-22T02:08:22.129" v="281" actId="1076"/>
          <ac:spMkLst>
            <pc:docMk/>
            <pc:sldMk cId="1037682986" sldId="257"/>
            <ac:spMk id="58" creationId="{DD4F08F9-5B11-7390-36F3-DB8D8A134D9B}"/>
          </ac:spMkLst>
        </pc:spChg>
        <pc:spChg chg="add mod">
          <ac:chgData name="Kyuwoong Kim" userId="c6581f603476f281" providerId="LiveId" clId="{AB3AD8FA-EAF4-40B3-BC33-1A83D204ECFD}" dt="2023-12-22T02:08:22.129" v="281" actId="1076"/>
          <ac:spMkLst>
            <pc:docMk/>
            <pc:sldMk cId="1037682986" sldId="257"/>
            <ac:spMk id="59" creationId="{3EDD9793-3B26-CE2E-C2F8-BFE20E640AE8}"/>
          </ac:spMkLst>
        </pc:spChg>
        <pc:spChg chg="add del mod">
          <ac:chgData name="Kyuwoong Kim" userId="c6581f603476f281" providerId="LiveId" clId="{AB3AD8FA-EAF4-40B3-BC33-1A83D204ECFD}" dt="2023-12-22T02:00:22.995" v="272"/>
          <ac:spMkLst>
            <pc:docMk/>
            <pc:sldMk cId="1037682986" sldId="257"/>
            <ac:spMk id="60" creationId="{E6ACCB72-2541-97A9-687F-17437B9C1537}"/>
          </ac:spMkLst>
        </pc:spChg>
        <pc:spChg chg="add del mod">
          <ac:chgData name="Kyuwoong Kim" userId="c6581f603476f281" providerId="LiveId" clId="{AB3AD8FA-EAF4-40B3-BC33-1A83D204ECFD}" dt="2023-12-22T02:00:22.995" v="272"/>
          <ac:spMkLst>
            <pc:docMk/>
            <pc:sldMk cId="1037682986" sldId="257"/>
            <ac:spMk id="61" creationId="{7FD862BE-D982-6681-A574-5B95AE049C4E}"/>
          </ac:spMkLst>
        </pc:spChg>
        <pc:picChg chg="add mod">
          <ac:chgData name="Kyuwoong Kim" userId="c6581f603476f281" providerId="LiveId" clId="{AB3AD8FA-EAF4-40B3-BC33-1A83D204ECFD}" dt="2023-12-22T02:08:22.129" v="281" actId="1076"/>
          <ac:picMkLst>
            <pc:docMk/>
            <pc:sldMk cId="1037682986" sldId="257"/>
            <ac:picMk id="3" creationId="{3DA2BF18-C613-9863-29D7-87EE3DC84849}"/>
          </ac:picMkLst>
        </pc:picChg>
        <pc:picChg chg="del">
          <ac:chgData name="Kyuwoong Kim" userId="c6581f603476f281" providerId="LiveId" clId="{AB3AD8FA-EAF4-40B3-BC33-1A83D204ECFD}" dt="2023-12-22T01:43:43.821" v="0" actId="478"/>
          <ac:picMkLst>
            <pc:docMk/>
            <pc:sldMk cId="1037682986" sldId="257"/>
            <ac:picMk id="4" creationId="{76F9B603-6D8E-F714-AEE6-F98BC0ACA0D4}"/>
          </ac:picMkLst>
        </pc:picChg>
        <pc:picChg chg="del">
          <ac:chgData name="Kyuwoong Kim" userId="c6581f603476f281" providerId="LiveId" clId="{AB3AD8FA-EAF4-40B3-BC33-1A83D204ECFD}" dt="2023-12-22T01:43:43.821" v="0" actId="478"/>
          <ac:picMkLst>
            <pc:docMk/>
            <pc:sldMk cId="1037682986" sldId="257"/>
            <ac:picMk id="5" creationId="{2930E2AB-5636-ECD4-5001-902CEB82A9B1}"/>
          </ac:picMkLst>
        </pc:picChg>
        <pc:picChg chg="del">
          <ac:chgData name="Kyuwoong Kim" userId="c6581f603476f281" providerId="LiveId" clId="{AB3AD8FA-EAF4-40B3-BC33-1A83D204ECFD}" dt="2023-12-22T01:43:46.770" v="1" actId="478"/>
          <ac:picMkLst>
            <pc:docMk/>
            <pc:sldMk cId="1037682986" sldId="257"/>
            <ac:picMk id="6" creationId="{3FB8751E-6F08-3B21-DDF5-36C5D992C365}"/>
          </ac:picMkLst>
        </pc:picChg>
        <pc:picChg chg="add mod">
          <ac:chgData name="Kyuwoong Kim" userId="c6581f603476f281" providerId="LiveId" clId="{AB3AD8FA-EAF4-40B3-BC33-1A83D204ECFD}" dt="2023-12-22T02:08:22.129" v="281" actId="1076"/>
          <ac:picMkLst>
            <pc:docMk/>
            <pc:sldMk cId="1037682986" sldId="257"/>
            <ac:picMk id="7" creationId="{7C63AA1C-3B9F-F182-95A6-FFB796DF3BDF}"/>
          </ac:picMkLst>
        </pc:picChg>
        <pc:picChg chg="add mod">
          <ac:chgData name="Kyuwoong Kim" userId="c6581f603476f281" providerId="LiveId" clId="{AB3AD8FA-EAF4-40B3-BC33-1A83D204ECFD}" dt="2023-12-22T02:08:22.129" v="281" actId="1076"/>
          <ac:picMkLst>
            <pc:docMk/>
            <pc:sldMk cId="1037682986" sldId="257"/>
            <ac:picMk id="8" creationId="{9ADBDB19-291D-762F-285E-37BC4E4DD745}"/>
          </ac:picMkLst>
        </pc:picChg>
        <pc:picChg chg="add mod">
          <ac:chgData name="Kyuwoong Kim" userId="c6581f603476f281" providerId="LiveId" clId="{AB3AD8FA-EAF4-40B3-BC33-1A83D204ECFD}" dt="2023-12-22T02:08:51.164" v="288" actId="1076"/>
          <ac:picMkLst>
            <pc:docMk/>
            <pc:sldMk cId="1037682986" sldId="257"/>
            <ac:picMk id="9" creationId="{07E698BB-6FF8-6B7E-9D41-A0B8AC24415D}"/>
          </ac:picMkLst>
        </pc:picChg>
        <pc:picChg chg="del">
          <ac:chgData name="Kyuwoong Kim" userId="c6581f603476f281" providerId="LiveId" clId="{AB3AD8FA-EAF4-40B3-BC33-1A83D204ECFD}" dt="2023-12-22T01:43:43.821" v="0" actId="478"/>
          <ac:picMkLst>
            <pc:docMk/>
            <pc:sldMk cId="1037682986" sldId="257"/>
            <ac:picMk id="10" creationId="{54EAECFE-5401-E253-5BC5-E2B323C35487}"/>
          </ac:picMkLst>
        </pc:picChg>
        <pc:picChg chg="del">
          <ac:chgData name="Kyuwoong Kim" userId="c6581f603476f281" providerId="LiveId" clId="{AB3AD8FA-EAF4-40B3-BC33-1A83D204ECFD}" dt="2023-12-22T01:43:43.821" v="0" actId="478"/>
          <ac:picMkLst>
            <pc:docMk/>
            <pc:sldMk cId="1037682986" sldId="257"/>
            <ac:picMk id="11" creationId="{425BBB78-A5C7-415B-792D-222BB52967C7}"/>
          </ac:picMkLst>
        </pc:picChg>
        <pc:picChg chg="del">
          <ac:chgData name="Kyuwoong Kim" userId="c6581f603476f281" providerId="LiveId" clId="{AB3AD8FA-EAF4-40B3-BC33-1A83D204ECFD}" dt="2023-12-22T01:43:46.770" v="1" actId="478"/>
          <ac:picMkLst>
            <pc:docMk/>
            <pc:sldMk cId="1037682986" sldId="257"/>
            <ac:picMk id="12" creationId="{FFC92689-9EAA-B81E-58F4-5D3F2122EF37}"/>
          </ac:picMkLst>
        </pc:picChg>
        <pc:picChg chg="add mod">
          <ac:chgData name="Kyuwoong Kim" userId="c6581f603476f281" providerId="LiveId" clId="{AB3AD8FA-EAF4-40B3-BC33-1A83D204ECFD}" dt="2023-12-22T02:08:51.164" v="288" actId="1076"/>
          <ac:picMkLst>
            <pc:docMk/>
            <pc:sldMk cId="1037682986" sldId="257"/>
            <ac:picMk id="13" creationId="{B53CCBB4-0B80-D41A-BC82-1969AE576977}"/>
          </ac:picMkLst>
        </pc:picChg>
        <pc:picChg chg="add mod">
          <ac:chgData name="Kyuwoong Kim" userId="c6581f603476f281" providerId="LiveId" clId="{AB3AD8FA-EAF4-40B3-BC33-1A83D204ECFD}" dt="2023-12-22T02:08:51.164" v="288" actId="1076"/>
          <ac:picMkLst>
            <pc:docMk/>
            <pc:sldMk cId="1037682986" sldId="257"/>
            <ac:picMk id="14" creationId="{9B354F50-063D-9DB5-9BDE-88FD7F5DC28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69455" y="1355149"/>
            <a:ext cx="10016729" cy="2882806"/>
          </a:xfrm>
        </p:spPr>
        <p:txBody>
          <a:bodyPr anchor="b"/>
          <a:lstStyle>
            <a:lvl1pPr algn="ctr">
              <a:defRPr sz="657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69455" y="4349128"/>
            <a:ext cx="10016729" cy="1999179"/>
          </a:xfrm>
        </p:spPr>
        <p:txBody>
          <a:bodyPr/>
          <a:lstStyle>
            <a:lvl1pPr marL="0" indent="0" algn="ctr">
              <a:buNone/>
              <a:defRPr sz="2629"/>
            </a:lvl1pPr>
            <a:lvl2pPr marL="500817" indent="0" algn="ctr">
              <a:buNone/>
              <a:defRPr sz="2191"/>
            </a:lvl2pPr>
            <a:lvl3pPr marL="1001634" indent="0" algn="ctr">
              <a:buNone/>
              <a:defRPr sz="1972"/>
            </a:lvl3pPr>
            <a:lvl4pPr marL="1502451" indent="0" algn="ctr">
              <a:buNone/>
              <a:defRPr sz="1753"/>
            </a:lvl4pPr>
            <a:lvl5pPr marL="2003268" indent="0" algn="ctr">
              <a:buNone/>
              <a:defRPr sz="1753"/>
            </a:lvl5pPr>
            <a:lvl6pPr marL="2504084" indent="0" algn="ctr">
              <a:buNone/>
              <a:defRPr sz="1753"/>
            </a:lvl6pPr>
            <a:lvl7pPr marL="3004901" indent="0" algn="ctr">
              <a:buNone/>
              <a:defRPr sz="1753"/>
            </a:lvl7pPr>
            <a:lvl8pPr marL="3505718" indent="0" algn="ctr">
              <a:buNone/>
              <a:defRPr sz="1753"/>
            </a:lvl8pPr>
            <a:lvl9pPr marL="4006535" indent="0" algn="ctr">
              <a:buNone/>
              <a:defRPr sz="1753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4866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8494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557629" y="440855"/>
            <a:ext cx="2879809" cy="701725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18200" y="440855"/>
            <a:ext cx="8472483" cy="701725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1787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8963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1244" y="2064351"/>
            <a:ext cx="11519238" cy="3444416"/>
          </a:xfrm>
        </p:spPr>
        <p:txBody>
          <a:bodyPr anchor="b"/>
          <a:lstStyle>
            <a:lvl1pPr>
              <a:defRPr sz="657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1244" y="5541352"/>
            <a:ext cx="11519238" cy="1811337"/>
          </a:xfrm>
        </p:spPr>
        <p:txBody>
          <a:bodyPr/>
          <a:lstStyle>
            <a:lvl1pPr marL="0" indent="0">
              <a:buNone/>
              <a:defRPr sz="2629">
                <a:solidFill>
                  <a:schemeClr val="tx1">
                    <a:tint val="75000"/>
                  </a:schemeClr>
                </a:solidFill>
              </a:defRPr>
            </a:lvl1pPr>
            <a:lvl2pPr marL="500817" indent="0">
              <a:buNone/>
              <a:defRPr sz="2191">
                <a:solidFill>
                  <a:schemeClr val="tx1">
                    <a:tint val="75000"/>
                  </a:schemeClr>
                </a:solidFill>
              </a:defRPr>
            </a:lvl2pPr>
            <a:lvl3pPr marL="1001634" indent="0">
              <a:buNone/>
              <a:defRPr sz="1972">
                <a:solidFill>
                  <a:schemeClr val="tx1">
                    <a:tint val="75000"/>
                  </a:schemeClr>
                </a:solidFill>
              </a:defRPr>
            </a:lvl3pPr>
            <a:lvl4pPr marL="1502451" indent="0">
              <a:buNone/>
              <a:defRPr sz="1753">
                <a:solidFill>
                  <a:schemeClr val="tx1">
                    <a:tint val="75000"/>
                  </a:schemeClr>
                </a:solidFill>
              </a:defRPr>
            </a:lvl4pPr>
            <a:lvl5pPr marL="2003268" indent="0">
              <a:buNone/>
              <a:defRPr sz="1753">
                <a:solidFill>
                  <a:schemeClr val="tx1">
                    <a:tint val="75000"/>
                  </a:schemeClr>
                </a:solidFill>
              </a:defRPr>
            </a:lvl5pPr>
            <a:lvl6pPr marL="2504084" indent="0">
              <a:buNone/>
              <a:defRPr sz="1753">
                <a:solidFill>
                  <a:schemeClr val="tx1">
                    <a:tint val="75000"/>
                  </a:schemeClr>
                </a:solidFill>
              </a:defRPr>
            </a:lvl6pPr>
            <a:lvl7pPr marL="3004901" indent="0">
              <a:buNone/>
              <a:defRPr sz="1753">
                <a:solidFill>
                  <a:schemeClr val="tx1">
                    <a:tint val="75000"/>
                  </a:schemeClr>
                </a:solidFill>
              </a:defRPr>
            </a:lvl7pPr>
            <a:lvl8pPr marL="3505718" indent="0">
              <a:buNone/>
              <a:defRPr sz="1753">
                <a:solidFill>
                  <a:schemeClr val="tx1">
                    <a:tint val="75000"/>
                  </a:schemeClr>
                </a:solidFill>
              </a:defRPr>
            </a:lvl8pPr>
            <a:lvl9pPr marL="4006535" indent="0">
              <a:buNone/>
              <a:defRPr sz="175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0796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18200" y="2204273"/>
            <a:ext cx="5676146" cy="52538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61292" y="2204273"/>
            <a:ext cx="5676146" cy="52538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87675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9940" y="440855"/>
            <a:ext cx="11519238" cy="160049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9940" y="2029849"/>
            <a:ext cx="5650060" cy="994797"/>
          </a:xfrm>
        </p:spPr>
        <p:txBody>
          <a:bodyPr anchor="b"/>
          <a:lstStyle>
            <a:lvl1pPr marL="0" indent="0">
              <a:buNone/>
              <a:defRPr sz="2629" b="1"/>
            </a:lvl1pPr>
            <a:lvl2pPr marL="500817" indent="0">
              <a:buNone/>
              <a:defRPr sz="2191" b="1"/>
            </a:lvl2pPr>
            <a:lvl3pPr marL="1001634" indent="0">
              <a:buNone/>
              <a:defRPr sz="1972" b="1"/>
            </a:lvl3pPr>
            <a:lvl4pPr marL="1502451" indent="0">
              <a:buNone/>
              <a:defRPr sz="1753" b="1"/>
            </a:lvl4pPr>
            <a:lvl5pPr marL="2003268" indent="0">
              <a:buNone/>
              <a:defRPr sz="1753" b="1"/>
            </a:lvl5pPr>
            <a:lvl6pPr marL="2504084" indent="0">
              <a:buNone/>
              <a:defRPr sz="1753" b="1"/>
            </a:lvl6pPr>
            <a:lvl7pPr marL="3004901" indent="0">
              <a:buNone/>
              <a:defRPr sz="1753" b="1"/>
            </a:lvl7pPr>
            <a:lvl8pPr marL="3505718" indent="0">
              <a:buNone/>
              <a:defRPr sz="1753" b="1"/>
            </a:lvl8pPr>
            <a:lvl9pPr marL="4006535" indent="0">
              <a:buNone/>
              <a:defRPr sz="1753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9940" y="3024646"/>
            <a:ext cx="5650060" cy="444879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761292" y="2029849"/>
            <a:ext cx="5677886" cy="994797"/>
          </a:xfrm>
        </p:spPr>
        <p:txBody>
          <a:bodyPr anchor="b"/>
          <a:lstStyle>
            <a:lvl1pPr marL="0" indent="0">
              <a:buNone/>
              <a:defRPr sz="2629" b="1"/>
            </a:lvl1pPr>
            <a:lvl2pPr marL="500817" indent="0">
              <a:buNone/>
              <a:defRPr sz="2191" b="1"/>
            </a:lvl2pPr>
            <a:lvl3pPr marL="1001634" indent="0">
              <a:buNone/>
              <a:defRPr sz="1972" b="1"/>
            </a:lvl3pPr>
            <a:lvl4pPr marL="1502451" indent="0">
              <a:buNone/>
              <a:defRPr sz="1753" b="1"/>
            </a:lvl4pPr>
            <a:lvl5pPr marL="2003268" indent="0">
              <a:buNone/>
              <a:defRPr sz="1753" b="1"/>
            </a:lvl5pPr>
            <a:lvl6pPr marL="2504084" indent="0">
              <a:buNone/>
              <a:defRPr sz="1753" b="1"/>
            </a:lvl6pPr>
            <a:lvl7pPr marL="3004901" indent="0">
              <a:buNone/>
              <a:defRPr sz="1753" b="1"/>
            </a:lvl7pPr>
            <a:lvl8pPr marL="3505718" indent="0">
              <a:buNone/>
              <a:defRPr sz="1753" b="1"/>
            </a:lvl8pPr>
            <a:lvl9pPr marL="4006535" indent="0">
              <a:buNone/>
              <a:defRPr sz="1753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761292" y="3024646"/>
            <a:ext cx="5677886" cy="444879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5124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52501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7235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9940" y="552027"/>
            <a:ext cx="4307541" cy="1932093"/>
          </a:xfrm>
        </p:spPr>
        <p:txBody>
          <a:bodyPr anchor="b"/>
          <a:lstStyle>
            <a:lvl1pPr>
              <a:defRPr sz="350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77886" y="1192225"/>
            <a:ext cx="6761292" cy="5884451"/>
          </a:xfrm>
        </p:spPr>
        <p:txBody>
          <a:bodyPr/>
          <a:lstStyle>
            <a:lvl1pPr>
              <a:defRPr sz="3505"/>
            </a:lvl1pPr>
            <a:lvl2pPr>
              <a:defRPr sz="3067"/>
            </a:lvl2pPr>
            <a:lvl3pPr>
              <a:defRPr sz="2629"/>
            </a:lvl3pPr>
            <a:lvl4pPr>
              <a:defRPr sz="2191"/>
            </a:lvl4pPr>
            <a:lvl5pPr>
              <a:defRPr sz="2191"/>
            </a:lvl5pPr>
            <a:lvl6pPr>
              <a:defRPr sz="2191"/>
            </a:lvl6pPr>
            <a:lvl7pPr>
              <a:defRPr sz="2191"/>
            </a:lvl7pPr>
            <a:lvl8pPr>
              <a:defRPr sz="2191"/>
            </a:lvl8pPr>
            <a:lvl9pPr>
              <a:defRPr sz="219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9940" y="2484120"/>
            <a:ext cx="4307541" cy="4602140"/>
          </a:xfrm>
        </p:spPr>
        <p:txBody>
          <a:bodyPr/>
          <a:lstStyle>
            <a:lvl1pPr marL="0" indent="0">
              <a:buNone/>
              <a:defRPr sz="1753"/>
            </a:lvl1pPr>
            <a:lvl2pPr marL="500817" indent="0">
              <a:buNone/>
              <a:defRPr sz="1534"/>
            </a:lvl2pPr>
            <a:lvl3pPr marL="1001634" indent="0">
              <a:buNone/>
              <a:defRPr sz="1314"/>
            </a:lvl3pPr>
            <a:lvl4pPr marL="1502451" indent="0">
              <a:buNone/>
              <a:defRPr sz="1095"/>
            </a:lvl4pPr>
            <a:lvl5pPr marL="2003268" indent="0">
              <a:buNone/>
              <a:defRPr sz="1095"/>
            </a:lvl5pPr>
            <a:lvl6pPr marL="2504084" indent="0">
              <a:buNone/>
              <a:defRPr sz="1095"/>
            </a:lvl6pPr>
            <a:lvl7pPr marL="3004901" indent="0">
              <a:buNone/>
              <a:defRPr sz="1095"/>
            </a:lvl7pPr>
            <a:lvl8pPr marL="3505718" indent="0">
              <a:buNone/>
              <a:defRPr sz="1095"/>
            </a:lvl8pPr>
            <a:lvl9pPr marL="4006535" indent="0">
              <a:buNone/>
              <a:defRPr sz="1095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339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9940" y="552027"/>
            <a:ext cx="4307541" cy="1932093"/>
          </a:xfrm>
        </p:spPr>
        <p:txBody>
          <a:bodyPr anchor="b"/>
          <a:lstStyle>
            <a:lvl1pPr>
              <a:defRPr sz="350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77886" y="1192225"/>
            <a:ext cx="6761292" cy="5884451"/>
          </a:xfrm>
        </p:spPr>
        <p:txBody>
          <a:bodyPr anchor="t"/>
          <a:lstStyle>
            <a:lvl1pPr marL="0" indent="0">
              <a:buNone/>
              <a:defRPr sz="3505"/>
            </a:lvl1pPr>
            <a:lvl2pPr marL="500817" indent="0">
              <a:buNone/>
              <a:defRPr sz="3067"/>
            </a:lvl2pPr>
            <a:lvl3pPr marL="1001634" indent="0">
              <a:buNone/>
              <a:defRPr sz="2629"/>
            </a:lvl3pPr>
            <a:lvl4pPr marL="1502451" indent="0">
              <a:buNone/>
              <a:defRPr sz="2191"/>
            </a:lvl4pPr>
            <a:lvl5pPr marL="2003268" indent="0">
              <a:buNone/>
              <a:defRPr sz="2191"/>
            </a:lvl5pPr>
            <a:lvl6pPr marL="2504084" indent="0">
              <a:buNone/>
              <a:defRPr sz="2191"/>
            </a:lvl6pPr>
            <a:lvl7pPr marL="3004901" indent="0">
              <a:buNone/>
              <a:defRPr sz="2191"/>
            </a:lvl7pPr>
            <a:lvl8pPr marL="3505718" indent="0">
              <a:buNone/>
              <a:defRPr sz="2191"/>
            </a:lvl8pPr>
            <a:lvl9pPr marL="4006535" indent="0">
              <a:buNone/>
              <a:defRPr sz="2191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9940" y="2484120"/>
            <a:ext cx="4307541" cy="4602140"/>
          </a:xfrm>
        </p:spPr>
        <p:txBody>
          <a:bodyPr/>
          <a:lstStyle>
            <a:lvl1pPr marL="0" indent="0">
              <a:buNone/>
              <a:defRPr sz="1753"/>
            </a:lvl1pPr>
            <a:lvl2pPr marL="500817" indent="0">
              <a:buNone/>
              <a:defRPr sz="1534"/>
            </a:lvl2pPr>
            <a:lvl3pPr marL="1001634" indent="0">
              <a:buNone/>
              <a:defRPr sz="1314"/>
            </a:lvl3pPr>
            <a:lvl4pPr marL="1502451" indent="0">
              <a:buNone/>
              <a:defRPr sz="1095"/>
            </a:lvl4pPr>
            <a:lvl5pPr marL="2003268" indent="0">
              <a:buNone/>
              <a:defRPr sz="1095"/>
            </a:lvl5pPr>
            <a:lvl6pPr marL="2504084" indent="0">
              <a:buNone/>
              <a:defRPr sz="1095"/>
            </a:lvl6pPr>
            <a:lvl7pPr marL="3004901" indent="0">
              <a:buNone/>
              <a:defRPr sz="1095"/>
            </a:lvl7pPr>
            <a:lvl8pPr marL="3505718" indent="0">
              <a:buNone/>
              <a:defRPr sz="1095"/>
            </a:lvl8pPr>
            <a:lvl9pPr marL="4006535" indent="0">
              <a:buNone/>
              <a:defRPr sz="1095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7289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8200" y="440855"/>
            <a:ext cx="11519238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8200" y="2204273"/>
            <a:ext cx="11519238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18200" y="7674704"/>
            <a:ext cx="3005019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1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424055" y="7674704"/>
            <a:ext cx="450752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1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432419" y="7674704"/>
            <a:ext cx="3005019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1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92467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001634" rtl="0" eaLnBrk="1" latinLnBrk="1" hangingPunct="1">
        <a:lnSpc>
          <a:spcPct val="90000"/>
        </a:lnSpc>
        <a:spcBef>
          <a:spcPct val="0"/>
        </a:spcBef>
        <a:buNone/>
        <a:defRPr sz="48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0408" indent="-250408" algn="l" defTabSz="1001634" rtl="0" eaLnBrk="1" latinLnBrk="1" hangingPunct="1">
        <a:lnSpc>
          <a:spcPct val="90000"/>
        </a:lnSpc>
        <a:spcBef>
          <a:spcPts val="1095"/>
        </a:spcBef>
        <a:buFont typeface="Arial" panose="020B0604020202020204" pitchFamily="34" charset="0"/>
        <a:buChar char="•"/>
        <a:defRPr sz="3067" kern="1200">
          <a:solidFill>
            <a:schemeClr val="tx1"/>
          </a:solidFill>
          <a:latin typeface="+mn-lt"/>
          <a:ea typeface="+mn-ea"/>
          <a:cs typeface="+mn-cs"/>
        </a:defRPr>
      </a:lvl1pPr>
      <a:lvl2pPr marL="751225" indent="-250408" algn="l" defTabSz="1001634" rtl="0" eaLnBrk="1" latinLnBrk="1" hangingPunct="1">
        <a:lnSpc>
          <a:spcPct val="90000"/>
        </a:lnSpc>
        <a:spcBef>
          <a:spcPts val="548"/>
        </a:spcBef>
        <a:buFont typeface="Arial" panose="020B0604020202020204" pitchFamily="34" charset="0"/>
        <a:buChar char="•"/>
        <a:defRPr sz="2629" kern="1200">
          <a:solidFill>
            <a:schemeClr val="tx1"/>
          </a:solidFill>
          <a:latin typeface="+mn-lt"/>
          <a:ea typeface="+mn-ea"/>
          <a:cs typeface="+mn-cs"/>
        </a:defRPr>
      </a:lvl2pPr>
      <a:lvl3pPr marL="1252042" indent="-250408" algn="l" defTabSz="1001634" rtl="0" eaLnBrk="1" latinLnBrk="1" hangingPunct="1">
        <a:lnSpc>
          <a:spcPct val="90000"/>
        </a:lnSpc>
        <a:spcBef>
          <a:spcPts val="548"/>
        </a:spcBef>
        <a:buFont typeface="Arial" panose="020B0604020202020204" pitchFamily="34" charset="0"/>
        <a:buChar char="•"/>
        <a:defRPr sz="2191" kern="1200">
          <a:solidFill>
            <a:schemeClr val="tx1"/>
          </a:solidFill>
          <a:latin typeface="+mn-lt"/>
          <a:ea typeface="+mn-ea"/>
          <a:cs typeface="+mn-cs"/>
        </a:defRPr>
      </a:lvl3pPr>
      <a:lvl4pPr marL="1752859" indent="-250408" algn="l" defTabSz="1001634" rtl="0" eaLnBrk="1" latinLnBrk="1" hangingPunct="1">
        <a:lnSpc>
          <a:spcPct val="90000"/>
        </a:lnSpc>
        <a:spcBef>
          <a:spcPts val="548"/>
        </a:spcBef>
        <a:buFont typeface="Arial" panose="020B0604020202020204" pitchFamily="34" charset="0"/>
        <a:buChar char="•"/>
        <a:defRPr sz="1972" kern="1200">
          <a:solidFill>
            <a:schemeClr val="tx1"/>
          </a:solidFill>
          <a:latin typeface="+mn-lt"/>
          <a:ea typeface="+mn-ea"/>
          <a:cs typeface="+mn-cs"/>
        </a:defRPr>
      </a:lvl4pPr>
      <a:lvl5pPr marL="2253676" indent="-250408" algn="l" defTabSz="1001634" rtl="0" eaLnBrk="1" latinLnBrk="1" hangingPunct="1">
        <a:lnSpc>
          <a:spcPct val="90000"/>
        </a:lnSpc>
        <a:spcBef>
          <a:spcPts val="548"/>
        </a:spcBef>
        <a:buFont typeface="Arial" panose="020B0604020202020204" pitchFamily="34" charset="0"/>
        <a:buChar char="•"/>
        <a:defRPr sz="1972" kern="1200">
          <a:solidFill>
            <a:schemeClr val="tx1"/>
          </a:solidFill>
          <a:latin typeface="+mn-lt"/>
          <a:ea typeface="+mn-ea"/>
          <a:cs typeface="+mn-cs"/>
        </a:defRPr>
      </a:lvl5pPr>
      <a:lvl6pPr marL="2754493" indent="-250408" algn="l" defTabSz="1001634" rtl="0" eaLnBrk="1" latinLnBrk="1" hangingPunct="1">
        <a:lnSpc>
          <a:spcPct val="90000"/>
        </a:lnSpc>
        <a:spcBef>
          <a:spcPts val="548"/>
        </a:spcBef>
        <a:buFont typeface="Arial" panose="020B0604020202020204" pitchFamily="34" charset="0"/>
        <a:buChar char="•"/>
        <a:defRPr sz="1972" kern="1200">
          <a:solidFill>
            <a:schemeClr val="tx1"/>
          </a:solidFill>
          <a:latin typeface="+mn-lt"/>
          <a:ea typeface="+mn-ea"/>
          <a:cs typeface="+mn-cs"/>
        </a:defRPr>
      </a:lvl6pPr>
      <a:lvl7pPr marL="3255310" indent="-250408" algn="l" defTabSz="1001634" rtl="0" eaLnBrk="1" latinLnBrk="1" hangingPunct="1">
        <a:lnSpc>
          <a:spcPct val="90000"/>
        </a:lnSpc>
        <a:spcBef>
          <a:spcPts val="548"/>
        </a:spcBef>
        <a:buFont typeface="Arial" panose="020B0604020202020204" pitchFamily="34" charset="0"/>
        <a:buChar char="•"/>
        <a:defRPr sz="1972" kern="1200">
          <a:solidFill>
            <a:schemeClr val="tx1"/>
          </a:solidFill>
          <a:latin typeface="+mn-lt"/>
          <a:ea typeface="+mn-ea"/>
          <a:cs typeface="+mn-cs"/>
        </a:defRPr>
      </a:lvl7pPr>
      <a:lvl8pPr marL="3756127" indent="-250408" algn="l" defTabSz="1001634" rtl="0" eaLnBrk="1" latinLnBrk="1" hangingPunct="1">
        <a:lnSpc>
          <a:spcPct val="90000"/>
        </a:lnSpc>
        <a:spcBef>
          <a:spcPts val="548"/>
        </a:spcBef>
        <a:buFont typeface="Arial" panose="020B0604020202020204" pitchFamily="34" charset="0"/>
        <a:buChar char="•"/>
        <a:defRPr sz="1972" kern="1200">
          <a:solidFill>
            <a:schemeClr val="tx1"/>
          </a:solidFill>
          <a:latin typeface="+mn-lt"/>
          <a:ea typeface="+mn-ea"/>
          <a:cs typeface="+mn-cs"/>
        </a:defRPr>
      </a:lvl8pPr>
      <a:lvl9pPr marL="4256943" indent="-250408" algn="l" defTabSz="1001634" rtl="0" eaLnBrk="1" latinLnBrk="1" hangingPunct="1">
        <a:lnSpc>
          <a:spcPct val="90000"/>
        </a:lnSpc>
        <a:spcBef>
          <a:spcPts val="548"/>
        </a:spcBef>
        <a:buFont typeface="Arial" panose="020B0604020202020204" pitchFamily="34" charset="0"/>
        <a:buChar char="•"/>
        <a:defRPr sz="19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1634" rtl="0" eaLnBrk="1" latinLnBrk="1" hangingPunct="1">
        <a:defRPr sz="1972" kern="1200">
          <a:solidFill>
            <a:schemeClr val="tx1"/>
          </a:solidFill>
          <a:latin typeface="+mn-lt"/>
          <a:ea typeface="+mn-ea"/>
          <a:cs typeface="+mn-cs"/>
        </a:defRPr>
      </a:lvl1pPr>
      <a:lvl2pPr marL="500817" algn="l" defTabSz="1001634" rtl="0" eaLnBrk="1" latinLnBrk="1" hangingPunct="1">
        <a:defRPr sz="1972" kern="1200">
          <a:solidFill>
            <a:schemeClr val="tx1"/>
          </a:solidFill>
          <a:latin typeface="+mn-lt"/>
          <a:ea typeface="+mn-ea"/>
          <a:cs typeface="+mn-cs"/>
        </a:defRPr>
      </a:lvl2pPr>
      <a:lvl3pPr marL="1001634" algn="l" defTabSz="1001634" rtl="0" eaLnBrk="1" latinLnBrk="1" hangingPunct="1">
        <a:defRPr sz="1972" kern="1200">
          <a:solidFill>
            <a:schemeClr val="tx1"/>
          </a:solidFill>
          <a:latin typeface="+mn-lt"/>
          <a:ea typeface="+mn-ea"/>
          <a:cs typeface="+mn-cs"/>
        </a:defRPr>
      </a:lvl3pPr>
      <a:lvl4pPr marL="1502451" algn="l" defTabSz="1001634" rtl="0" eaLnBrk="1" latinLnBrk="1" hangingPunct="1">
        <a:defRPr sz="1972" kern="1200">
          <a:solidFill>
            <a:schemeClr val="tx1"/>
          </a:solidFill>
          <a:latin typeface="+mn-lt"/>
          <a:ea typeface="+mn-ea"/>
          <a:cs typeface="+mn-cs"/>
        </a:defRPr>
      </a:lvl4pPr>
      <a:lvl5pPr marL="2003268" algn="l" defTabSz="1001634" rtl="0" eaLnBrk="1" latinLnBrk="1" hangingPunct="1">
        <a:defRPr sz="1972" kern="1200">
          <a:solidFill>
            <a:schemeClr val="tx1"/>
          </a:solidFill>
          <a:latin typeface="+mn-lt"/>
          <a:ea typeface="+mn-ea"/>
          <a:cs typeface="+mn-cs"/>
        </a:defRPr>
      </a:lvl5pPr>
      <a:lvl6pPr marL="2504084" algn="l" defTabSz="1001634" rtl="0" eaLnBrk="1" latinLnBrk="1" hangingPunct="1">
        <a:defRPr sz="1972" kern="1200">
          <a:solidFill>
            <a:schemeClr val="tx1"/>
          </a:solidFill>
          <a:latin typeface="+mn-lt"/>
          <a:ea typeface="+mn-ea"/>
          <a:cs typeface="+mn-cs"/>
        </a:defRPr>
      </a:lvl6pPr>
      <a:lvl7pPr marL="3004901" algn="l" defTabSz="1001634" rtl="0" eaLnBrk="1" latinLnBrk="1" hangingPunct="1">
        <a:defRPr sz="1972" kern="1200">
          <a:solidFill>
            <a:schemeClr val="tx1"/>
          </a:solidFill>
          <a:latin typeface="+mn-lt"/>
          <a:ea typeface="+mn-ea"/>
          <a:cs typeface="+mn-cs"/>
        </a:defRPr>
      </a:lvl7pPr>
      <a:lvl8pPr marL="3505718" algn="l" defTabSz="1001634" rtl="0" eaLnBrk="1" latinLnBrk="1" hangingPunct="1">
        <a:defRPr sz="1972" kern="1200">
          <a:solidFill>
            <a:schemeClr val="tx1"/>
          </a:solidFill>
          <a:latin typeface="+mn-lt"/>
          <a:ea typeface="+mn-ea"/>
          <a:cs typeface="+mn-cs"/>
        </a:defRPr>
      </a:lvl8pPr>
      <a:lvl9pPr marL="4006535" algn="l" defTabSz="1001634" rtl="0" eaLnBrk="1" latinLnBrk="1" hangingPunct="1">
        <a:defRPr sz="19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 descr="스크린샷, 텍스트, 도표, 직사각형이(가) 표시된 사진&#10;&#10;자동 생성된 설명">
            <a:extLst>
              <a:ext uri="{FF2B5EF4-FFF2-40B4-BE49-F238E27FC236}">
                <a16:creationId xmlns:a16="http://schemas.microsoft.com/office/drawing/2014/main" id="{89F1FC39-C451-D940-77C3-EB949E3015F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74903" y="4516863"/>
            <a:ext cx="3501816" cy="3207150"/>
          </a:xfrm>
          <a:prstGeom prst="rect">
            <a:avLst/>
          </a:prstGeom>
        </p:spPr>
      </p:pic>
      <p:pic>
        <p:nvPicPr>
          <p:cNvPr id="4" name="그림 3" descr="도표, 스크린샷, 텍스트, 직사각형이(가) 표시된 사진&#10;&#10;자동 생성된 설명">
            <a:extLst>
              <a:ext uri="{FF2B5EF4-FFF2-40B4-BE49-F238E27FC236}">
                <a16:creationId xmlns:a16="http://schemas.microsoft.com/office/drawing/2014/main" id="{78CFC0BB-A8AA-3A99-B3A4-0F096EF75EF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1349" y="4451558"/>
            <a:ext cx="3627664" cy="3207151"/>
          </a:xfrm>
          <a:prstGeom prst="rect">
            <a:avLst/>
          </a:prstGeom>
        </p:spPr>
      </p:pic>
      <p:pic>
        <p:nvPicPr>
          <p:cNvPr id="5" name="그림 4" descr="스크린샷, 도표, 텍스트, 직사각형이(가) 표시된 사진&#10;&#10;자동 생성된 설명">
            <a:extLst>
              <a:ext uri="{FF2B5EF4-FFF2-40B4-BE49-F238E27FC236}">
                <a16:creationId xmlns:a16="http://schemas.microsoft.com/office/drawing/2014/main" id="{B7846E34-7695-90B4-ED71-8D35E87029B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0117" y="4367406"/>
            <a:ext cx="3616443" cy="3272457"/>
          </a:xfrm>
          <a:prstGeom prst="rect">
            <a:avLst/>
          </a:prstGeom>
        </p:spPr>
      </p:pic>
      <p:pic>
        <p:nvPicPr>
          <p:cNvPr id="6" name="그림 5" descr="도표, 텍스트, 라인, 기술 도면이(가) 표시된 사진&#10;&#10;자동 생성된 설명">
            <a:extLst>
              <a:ext uri="{FF2B5EF4-FFF2-40B4-BE49-F238E27FC236}">
                <a16:creationId xmlns:a16="http://schemas.microsoft.com/office/drawing/2014/main" id="{05B99E67-0C4F-310E-2828-FDAFE392684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07219" y="1341709"/>
            <a:ext cx="3511793" cy="3116692"/>
          </a:xfrm>
          <a:prstGeom prst="rect">
            <a:avLst/>
          </a:prstGeom>
        </p:spPr>
      </p:pic>
      <p:pic>
        <p:nvPicPr>
          <p:cNvPr id="10" name="그림 9" descr="도표, 스크린샷, 텍스트, 라인이(가) 표시된 사진&#10;&#10;자동 생성된 설명">
            <a:extLst>
              <a:ext uri="{FF2B5EF4-FFF2-40B4-BE49-F238E27FC236}">
                <a16:creationId xmlns:a16="http://schemas.microsoft.com/office/drawing/2014/main" id="{184CEB08-BB23-794B-AD8A-86F485ED0A7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3587" y="1289247"/>
            <a:ext cx="3525823" cy="3196548"/>
          </a:xfrm>
          <a:prstGeom prst="rect">
            <a:avLst/>
          </a:prstGeom>
        </p:spPr>
      </p:pic>
      <p:pic>
        <p:nvPicPr>
          <p:cNvPr id="11" name="그림 10" descr="도표, 텍스트, 스크린샷, 직사각형이(가) 표시된 사진&#10;&#10;자동 생성된 설명">
            <a:extLst>
              <a:ext uri="{FF2B5EF4-FFF2-40B4-BE49-F238E27FC236}">
                <a16:creationId xmlns:a16="http://schemas.microsoft.com/office/drawing/2014/main" id="{0D3255E8-C6D7-5AB4-41DB-A9E9AED6C33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4236" y="1334861"/>
            <a:ext cx="3660488" cy="3196548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0110422B-A330-DB43-E93C-5DF9FB920B6B}"/>
              </a:ext>
            </a:extLst>
          </p:cNvPr>
          <p:cNvSpPr txBox="1"/>
          <p:nvPr/>
        </p:nvSpPr>
        <p:spPr>
          <a:xfrm>
            <a:off x="1211341" y="1359984"/>
            <a:ext cx="3599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>
              <a:buAutoNum type="alphaUcParenBoth"/>
            </a:pPr>
            <a:r>
              <a:rPr lang="en-US" altLang="ko-KR" sz="1200" b="1" dirty="0"/>
              <a:t>All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7621210-4DEB-DC03-123C-1F7219027A33}"/>
              </a:ext>
            </a:extLst>
          </p:cNvPr>
          <p:cNvSpPr txBox="1"/>
          <p:nvPr/>
        </p:nvSpPr>
        <p:spPr>
          <a:xfrm rot="16200000">
            <a:off x="4303539" y="5570817"/>
            <a:ext cx="133428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Lean body mass</a:t>
            </a:r>
            <a:endParaRPr lang="ko-KR" altLang="en-US" sz="12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F4EDBFB-743C-9551-9B31-900B8968843C}"/>
              </a:ext>
            </a:extLst>
          </p:cNvPr>
          <p:cNvSpPr txBox="1"/>
          <p:nvPr/>
        </p:nvSpPr>
        <p:spPr>
          <a:xfrm rot="16200000">
            <a:off x="8495991" y="5570817"/>
            <a:ext cx="133428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Lean body mass</a:t>
            </a:r>
            <a:endParaRPr lang="ko-KR" altLang="en-US" sz="12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0AB1660-B3CE-77D2-5D8C-D8408DC702D9}"/>
              </a:ext>
            </a:extLst>
          </p:cNvPr>
          <p:cNvSpPr txBox="1"/>
          <p:nvPr/>
        </p:nvSpPr>
        <p:spPr>
          <a:xfrm rot="16200000">
            <a:off x="-42151" y="2552100"/>
            <a:ext cx="1779757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Body fat mass (kg)</a:t>
            </a:r>
            <a:endParaRPr lang="ko-KR" altLang="en-US" sz="10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1517E53-6946-C0A4-3CEB-705AB7147267}"/>
              </a:ext>
            </a:extLst>
          </p:cNvPr>
          <p:cNvSpPr txBox="1"/>
          <p:nvPr/>
        </p:nvSpPr>
        <p:spPr>
          <a:xfrm rot="16200000">
            <a:off x="4338073" y="2462724"/>
            <a:ext cx="133428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Body Fat mass</a:t>
            </a:r>
            <a:endParaRPr lang="ko-KR" altLang="en-US" sz="12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36D7B9A-9813-1BD4-26D6-5FCAFEC49DC0}"/>
              </a:ext>
            </a:extLst>
          </p:cNvPr>
          <p:cNvSpPr txBox="1"/>
          <p:nvPr/>
        </p:nvSpPr>
        <p:spPr>
          <a:xfrm rot="16200000">
            <a:off x="8540076" y="2462724"/>
            <a:ext cx="133428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Body Fat mass</a:t>
            </a:r>
            <a:endParaRPr lang="ko-KR" altLang="en-US" sz="12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5830CAC-6B12-E0E8-422D-B6C9400A1632}"/>
              </a:ext>
            </a:extLst>
          </p:cNvPr>
          <p:cNvSpPr txBox="1"/>
          <p:nvPr/>
        </p:nvSpPr>
        <p:spPr>
          <a:xfrm rot="16200000">
            <a:off x="4199990" y="5686108"/>
            <a:ext cx="166271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50" dirty="0"/>
              <a:t>Lean body mass (kg)</a:t>
            </a:r>
            <a:endParaRPr lang="ko-KR" altLang="en-US" sz="105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9842221-111E-3077-4793-03A331493134}"/>
              </a:ext>
            </a:extLst>
          </p:cNvPr>
          <p:cNvSpPr txBox="1"/>
          <p:nvPr/>
        </p:nvSpPr>
        <p:spPr>
          <a:xfrm rot="16200000">
            <a:off x="4141474" y="2460119"/>
            <a:ext cx="177975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50" dirty="0"/>
              <a:t>Body fat mass (kg)</a:t>
            </a:r>
            <a:endParaRPr lang="ko-KR" altLang="en-US" sz="105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1EB41B9-F25F-6955-8F1D-4E3E210433FC}"/>
              </a:ext>
            </a:extLst>
          </p:cNvPr>
          <p:cNvSpPr txBox="1"/>
          <p:nvPr/>
        </p:nvSpPr>
        <p:spPr>
          <a:xfrm rot="16200000">
            <a:off x="8293702" y="5794498"/>
            <a:ext cx="166271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50" dirty="0"/>
              <a:t>Lean body mass (kg)</a:t>
            </a:r>
            <a:endParaRPr lang="ko-KR" altLang="en-US" sz="105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B886F77-C41C-CC57-767F-E8CFA9FF7E04}"/>
              </a:ext>
            </a:extLst>
          </p:cNvPr>
          <p:cNvSpPr txBox="1"/>
          <p:nvPr/>
        </p:nvSpPr>
        <p:spPr>
          <a:xfrm>
            <a:off x="5369436" y="1390492"/>
            <a:ext cx="3599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(B) Men 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B923759-EE7D-5F6F-083F-A2A6D42FF4E3}"/>
              </a:ext>
            </a:extLst>
          </p:cNvPr>
          <p:cNvSpPr txBox="1"/>
          <p:nvPr/>
        </p:nvSpPr>
        <p:spPr>
          <a:xfrm>
            <a:off x="9525437" y="1345122"/>
            <a:ext cx="3599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(C) Women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E099F1B-C4B0-CB68-3D46-F97CB0D9FA0B}"/>
              </a:ext>
            </a:extLst>
          </p:cNvPr>
          <p:cNvSpPr txBox="1"/>
          <p:nvPr/>
        </p:nvSpPr>
        <p:spPr>
          <a:xfrm>
            <a:off x="1220350" y="4471168"/>
            <a:ext cx="3599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(D) All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66B1B07-D5D4-8078-C2BF-925F81997393}"/>
              </a:ext>
            </a:extLst>
          </p:cNvPr>
          <p:cNvSpPr txBox="1"/>
          <p:nvPr/>
        </p:nvSpPr>
        <p:spPr>
          <a:xfrm>
            <a:off x="5348843" y="4485798"/>
            <a:ext cx="3599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(E) Men 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CFE6C89-8253-9163-0D05-478393A537F7}"/>
              </a:ext>
            </a:extLst>
          </p:cNvPr>
          <p:cNvSpPr txBox="1"/>
          <p:nvPr/>
        </p:nvSpPr>
        <p:spPr>
          <a:xfrm>
            <a:off x="9508712" y="4509686"/>
            <a:ext cx="3599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(F) Women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22735BE-5519-093A-F7CB-E3D635556409}"/>
              </a:ext>
            </a:extLst>
          </p:cNvPr>
          <p:cNvSpPr txBox="1"/>
          <p:nvPr/>
        </p:nvSpPr>
        <p:spPr>
          <a:xfrm>
            <a:off x="1823397" y="7138724"/>
            <a:ext cx="65623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Actual </a:t>
            </a:r>
            <a:endParaRPr lang="ko-KR" altLang="en-US" sz="10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0515DB5-2198-0BD1-261B-331C1CC43A0F}"/>
              </a:ext>
            </a:extLst>
          </p:cNvPr>
          <p:cNvSpPr txBox="1"/>
          <p:nvPr/>
        </p:nvSpPr>
        <p:spPr>
          <a:xfrm>
            <a:off x="3020349" y="7140203"/>
            <a:ext cx="7749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Predicted </a:t>
            </a:r>
            <a:endParaRPr lang="ko-KR" altLang="en-US" sz="1000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8E6E8D2-F0CF-7635-08AB-13818695D9FD}"/>
              </a:ext>
            </a:extLst>
          </p:cNvPr>
          <p:cNvSpPr txBox="1"/>
          <p:nvPr/>
        </p:nvSpPr>
        <p:spPr>
          <a:xfrm>
            <a:off x="6018879" y="7159940"/>
            <a:ext cx="65623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Actual </a:t>
            </a:r>
            <a:endParaRPr lang="ko-KR" altLang="en-US" sz="10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8E86152-40C0-3EC5-B47C-887EC496857E}"/>
              </a:ext>
            </a:extLst>
          </p:cNvPr>
          <p:cNvSpPr txBox="1"/>
          <p:nvPr/>
        </p:nvSpPr>
        <p:spPr>
          <a:xfrm>
            <a:off x="7242277" y="7190557"/>
            <a:ext cx="7749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Predicted </a:t>
            </a:r>
            <a:endParaRPr lang="ko-KR" altLang="en-US" sz="10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76C66C2-A7C7-B858-D717-0AAC2D46539E}"/>
              </a:ext>
            </a:extLst>
          </p:cNvPr>
          <p:cNvSpPr txBox="1"/>
          <p:nvPr/>
        </p:nvSpPr>
        <p:spPr>
          <a:xfrm>
            <a:off x="10137267" y="7235625"/>
            <a:ext cx="65623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Actual </a:t>
            </a:r>
            <a:endParaRPr lang="ko-KR" altLang="en-US" sz="10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A47FEAD-69CC-726F-A02C-A9A4AC48BC06}"/>
              </a:ext>
            </a:extLst>
          </p:cNvPr>
          <p:cNvSpPr txBox="1"/>
          <p:nvPr/>
        </p:nvSpPr>
        <p:spPr>
          <a:xfrm>
            <a:off x="11325437" y="7283050"/>
            <a:ext cx="7749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Predicted </a:t>
            </a:r>
            <a:endParaRPr lang="ko-KR" altLang="en-US" sz="1000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6717F8D1-BF07-A098-4DC1-4AAD52E17891}"/>
              </a:ext>
            </a:extLst>
          </p:cNvPr>
          <p:cNvSpPr txBox="1"/>
          <p:nvPr/>
        </p:nvSpPr>
        <p:spPr>
          <a:xfrm>
            <a:off x="1783148" y="4024531"/>
            <a:ext cx="65623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Actual </a:t>
            </a:r>
            <a:endParaRPr lang="ko-KR" altLang="en-US" sz="1000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EF4E0080-96C2-16C3-95B9-1A58C94F5A70}"/>
              </a:ext>
            </a:extLst>
          </p:cNvPr>
          <p:cNvSpPr txBox="1"/>
          <p:nvPr/>
        </p:nvSpPr>
        <p:spPr>
          <a:xfrm>
            <a:off x="2885691" y="4031550"/>
            <a:ext cx="7749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Predicted </a:t>
            </a:r>
            <a:endParaRPr lang="ko-KR" altLang="en-US" sz="1000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A8E53E1A-EAD9-987A-69DE-A3539E8F3A24}"/>
              </a:ext>
            </a:extLst>
          </p:cNvPr>
          <p:cNvSpPr txBox="1"/>
          <p:nvPr/>
        </p:nvSpPr>
        <p:spPr>
          <a:xfrm>
            <a:off x="5951096" y="4024531"/>
            <a:ext cx="65623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Actual </a:t>
            </a:r>
            <a:endParaRPr lang="ko-KR" altLang="en-US" sz="10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8599CB8-A876-D470-D910-AF42CADEE583}"/>
              </a:ext>
            </a:extLst>
          </p:cNvPr>
          <p:cNvSpPr txBox="1"/>
          <p:nvPr/>
        </p:nvSpPr>
        <p:spPr>
          <a:xfrm>
            <a:off x="7053639" y="4031550"/>
            <a:ext cx="7749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Predicted </a:t>
            </a:r>
            <a:endParaRPr lang="ko-KR" altLang="en-US" sz="10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D4F08F9-5B11-7390-36F3-DB8D8A134D9B}"/>
              </a:ext>
            </a:extLst>
          </p:cNvPr>
          <p:cNvSpPr txBox="1"/>
          <p:nvPr/>
        </p:nvSpPr>
        <p:spPr>
          <a:xfrm>
            <a:off x="10137268" y="3976353"/>
            <a:ext cx="65623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Actual </a:t>
            </a:r>
            <a:endParaRPr lang="ko-KR" altLang="en-US" sz="10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3EDD9793-3B26-CE2E-C2F8-BFE20E640AE8}"/>
              </a:ext>
            </a:extLst>
          </p:cNvPr>
          <p:cNvSpPr txBox="1"/>
          <p:nvPr/>
        </p:nvSpPr>
        <p:spPr>
          <a:xfrm>
            <a:off x="11239811" y="3983372"/>
            <a:ext cx="7749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Predicted </a:t>
            </a:r>
            <a:endParaRPr lang="ko-KR" altLang="en-US" sz="10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81649CF-8F1A-BE31-7BC6-0C48E9FF9B97}"/>
              </a:ext>
            </a:extLst>
          </p:cNvPr>
          <p:cNvSpPr txBox="1"/>
          <p:nvPr/>
        </p:nvSpPr>
        <p:spPr>
          <a:xfrm rot="16200000">
            <a:off x="8288154" y="2544403"/>
            <a:ext cx="177975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50" dirty="0"/>
              <a:t>Body fat mass (kg)</a:t>
            </a:r>
            <a:endParaRPr lang="ko-KR" altLang="en-US" sz="105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2112411-3BB9-15BD-96F2-4DFAD9EE62C8}"/>
              </a:ext>
            </a:extLst>
          </p:cNvPr>
          <p:cNvSpPr txBox="1"/>
          <p:nvPr/>
        </p:nvSpPr>
        <p:spPr>
          <a:xfrm rot="16200000">
            <a:off x="15811" y="5693806"/>
            <a:ext cx="166271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Lean body mass (kg)</a:t>
            </a:r>
            <a:endParaRPr lang="ko-KR" altLang="en-US" sz="10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9CF38EF-56BB-5B5F-9603-974CFEE48FEC}"/>
              </a:ext>
            </a:extLst>
          </p:cNvPr>
          <p:cNvSpPr txBox="1"/>
          <p:nvPr/>
        </p:nvSpPr>
        <p:spPr>
          <a:xfrm>
            <a:off x="62141" y="18381"/>
            <a:ext cx="129562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/>
              <a:t>Supplementary </a:t>
            </a:r>
            <a:r>
              <a:rPr lang="en-US" altLang="ko-KR" b="1" dirty="0"/>
              <a:t>Figure 3. </a:t>
            </a:r>
            <a:r>
              <a:rPr lang="en-US" altLang="ko-KR" dirty="0"/>
              <a:t>Boxplots comparing actual and predicted values of body fat mass and lean body mass in adult cancer survivors without obesity (body mass index&lt;25.0 kg/m</a:t>
            </a:r>
            <a:r>
              <a:rPr lang="en-US" altLang="ko-KR" baseline="30000" dirty="0"/>
              <a:t>2</a:t>
            </a:r>
            <a:r>
              <a:rPr lang="en-US" altLang="ko-KR" dirty="0"/>
              <a:t>) in the Korean National Health and Nutrition Examination Survey (2008-2011)</a:t>
            </a:r>
            <a:endParaRPr lang="ko-KR" altLang="ko-KR" dirty="0"/>
          </a:p>
        </p:txBody>
      </p:sp>
    </p:spTree>
    <p:extLst>
      <p:ext uri="{BB962C8B-B14F-4D97-AF65-F5344CB8AC3E}">
        <p14:creationId xmlns:p14="http://schemas.microsoft.com/office/powerpoint/2010/main" val="10376829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643</TotalTime>
  <Words>127</Words>
  <Application>Microsoft Office PowerPoint</Application>
  <PresentationFormat>사용자 지정</PresentationFormat>
  <Paragraphs>2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국립암센터 호스피스완화의료사업과</dc:creator>
  <cp:lastModifiedBy>NCC</cp:lastModifiedBy>
  <cp:revision>12</cp:revision>
  <dcterms:created xsi:type="dcterms:W3CDTF">2023-06-13T23:55:47Z</dcterms:created>
  <dcterms:modified xsi:type="dcterms:W3CDTF">2023-12-27T04:49:27Z</dcterms:modified>
</cp:coreProperties>
</file>